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2" r:id="rId4"/>
    <p:sldId id="263" r:id="rId5"/>
    <p:sldId id="264" r:id="rId6"/>
    <p:sldId id="265" r:id="rId7"/>
    <p:sldId id="266" r:id="rId8"/>
    <p:sldId id="267" r:id="rId9"/>
    <p:sldId id="268" r:id="rId10"/>
    <p:sldId id="269" r:id="rId11"/>
    <p:sldId id="270" r:id="rId12"/>
    <p:sldId id="271" r:id="rId13"/>
    <p:sldId id="272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98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8476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9810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4677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6775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879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8516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623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282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343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1137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1946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167AD7-A5B1-437D-A6E3-4F99C53244F6}" type="datetimeFigureOut">
              <a:rPr lang="en-GB" smtClean="0"/>
              <a:t>04/07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A62A7A-662A-4E45-A38B-B25952536E1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3574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1"/>
          <p:cNvSpPr txBox="1">
            <a:spLocks/>
          </p:cNvSpPr>
          <p:nvPr/>
        </p:nvSpPr>
        <p:spPr>
          <a:xfrm>
            <a:off x="2057400" y="1048464"/>
            <a:ext cx="5829120" cy="48320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625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mtClean="0"/>
              <a:t>Source Data File</a:t>
            </a:r>
          </a:p>
          <a:p>
            <a:endParaRPr lang="de-DE" smtClean="0"/>
          </a:p>
          <a:p>
            <a:r>
              <a:rPr lang="de-DE" smtClean="0"/>
              <a:t>Fig. 7</a:t>
            </a:r>
            <a:br>
              <a:rPr lang="de-DE" smtClean="0"/>
            </a:br>
            <a:r>
              <a:rPr lang="de-DE" smtClean="0"/>
              <a:t/>
            </a:r>
            <a:br>
              <a:rPr lang="de-DE" smtClean="0"/>
            </a:br>
            <a:r>
              <a:rPr lang="en-US" b="1" smtClean="0"/>
              <a:t>Space Station conditions are selective but do not alter microbial characteristics relevant to human health</a:t>
            </a:r>
            <a:r>
              <a:rPr lang="de-DE" smtClean="0"/>
              <a:t/>
            </a:r>
            <a:br>
              <a:rPr lang="de-DE" smtClean="0"/>
            </a:br>
            <a:r>
              <a:rPr lang="en-US" b="1" smtClean="0"/>
              <a:t> </a:t>
            </a:r>
            <a:r>
              <a:rPr lang="de-DE" smtClean="0"/>
              <a:t/>
            </a:r>
            <a:br>
              <a:rPr lang="de-DE" smtClean="0"/>
            </a:br>
            <a:r>
              <a:rPr lang="en-GB" smtClean="0"/>
              <a:t>Maximilian Mora et al.</a:t>
            </a:r>
            <a:br>
              <a:rPr lang="en-GB" smtClean="0"/>
            </a:br>
            <a:r>
              <a:rPr lang="en-GB" smtClean="0"/>
              <a:t/>
            </a:r>
            <a:br>
              <a:rPr lang="en-GB" smtClean="0"/>
            </a:br>
            <a:r>
              <a:rPr lang="en-GB" smtClean="0"/>
              <a:t/>
            </a:r>
            <a:br>
              <a:rPr lang="en-GB" smtClean="0"/>
            </a:b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09383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I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610395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J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192676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K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9347339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L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691716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A (original image)</a:t>
            </a:r>
            <a:endParaRPr lang="en-GB" sz="2400"/>
          </a:p>
        </p:txBody>
      </p:sp>
      <p:pic>
        <p:nvPicPr>
          <p:cNvPr id="1026" name="Picture 2" descr="C:\Users\MoisslC\ownCloud\Manuscripts2\ISS publication\Submission Nature communications final version\Source Data Fig 7\2201_BLN1_01_Fig.7A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2999" y="948836"/>
            <a:ext cx="7675685" cy="5756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50970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B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5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783033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C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6650329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D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193768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E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907946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F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656338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G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191158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de-DE" sz="2400" smtClean="0"/>
              <a:t>Fig. 7H (original image)</a:t>
            </a:r>
            <a:endParaRPr lang="en-GB" sz="240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142999" y="948836"/>
            <a:ext cx="7675684" cy="5756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9792786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Bildschirmpräsentation (4:3)</PresentationFormat>
  <Paragraphs>15</Paragraphs>
  <Slides>1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14" baseType="lpstr">
      <vt:lpstr>Larissa</vt:lpstr>
      <vt:lpstr>PowerPoint-Präsentation</vt:lpstr>
      <vt:lpstr>Fig. 7A (original image)</vt:lpstr>
      <vt:lpstr>Fig. 7B (original image)</vt:lpstr>
      <vt:lpstr>Fig. 7C (original image)</vt:lpstr>
      <vt:lpstr>Fig. 7D (original image)</vt:lpstr>
      <vt:lpstr>Fig. 7E (original image)</vt:lpstr>
      <vt:lpstr>Fig. 7F (original image)</vt:lpstr>
      <vt:lpstr>Fig. 7G (original image)</vt:lpstr>
      <vt:lpstr>Fig. 7H (original image)</vt:lpstr>
      <vt:lpstr>Fig. 7I (original image)</vt:lpstr>
      <vt:lpstr>Fig. 7J (original image)</vt:lpstr>
      <vt:lpstr>Fig. 7K (original image)</vt:lpstr>
      <vt:lpstr>Fig. 7L (original image)</vt:lpstr>
    </vt:vector>
  </TitlesOfParts>
  <Company>KAG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oissl-Eichinger Christine, Univ.Prof.Dr.</dc:creator>
  <cp:lastModifiedBy>Moissl-Eichinger Christine, Univ.Prof.Dr.</cp:lastModifiedBy>
  <cp:revision>1</cp:revision>
  <dcterms:created xsi:type="dcterms:W3CDTF">2019-07-04T14:53:08Z</dcterms:created>
  <dcterms:modified xsi:type="dcterms:W3CDTF">2019-07-04T14:59:21Z</dcterms:modified>
</cp:coreProperties>
</file>